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>
      <p:cViewPr varScale="1">
        <p:scale>
          <a:sx n="124" d="100"/>
          <a:sy n="124" d="100"/>
        </p:scale>
        <p:origin x="6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hakal, Kshitiz" userId="6ff78c19-3d13-44c6-91c3-34d44c8b7c49" providerId="ADAL" clId="{EF817F6B-6A0D-4BA2-9C68-FBAAAAC31A2A}"/>
    <pc:docChg chg="custSel addSld delSld modSld">
      <pc:chgData name="Dhakal, Kshitiz" userId="6ff78c19-3d13-44c6-91c3-34d44c8b7c49" providerId="ADAL" clId="{EF817F6B-6A0D-4BA2-9C68-FBAAAAC31A2A}" dt="2022-12-27T21:22:38.038" v="5"/>
      <pc:docMkLst>
        <pc:docMk/>
      </pc:docMkLst>
      <pc:sldChg chg="add del">
        <pc:chgData name="Dhakal, Kshitiz" userId="6ff78c19-3d13-44c6-91c3-34d44c8b7c49" providerId="ADAL" clId="{EF817F6B-6A0D-4BA2-9C68-FBAAAAC31A2A}" dt="2022-12-27T21:22:32.797" v="2" actId="2696"/>
        <pc:sldMkLst>
          <pc:docMk/>
          <pc:sldMk cId="487417115" sldId="256"/>
        </pc:sldMkLst>
      </pc:sldChg>
      <pc:sldChg chg="addSp delSp modSp add">
        <pc:chgData name="Dhakal, Kshitiz" userId="6ff78c19-3d13-44c6-91c3-34d44c8b7c49" providerId="ADAL" clId="{EF817F6B-6A0D-4BA2-9C68-FBAAAAC31A2A}" dt="2022-12-27T21:22:38.038" v="5"/>
        <pc:sldMkLst>
          <pc:docMk/>
          <pc:sldMk cId="1598705153" sldId="257"/>
        </pc:sldMkLst>
        <pc:spChg chg="del">
          <ac:chgData name="Dhakal, Kshitiz" userId="6ff78c19-3d13-44c6-91c3-34d44c8b7c49" providerId="ADAL" clId="{EF817F6B-6A0D-4BA2-9C68-FBAAAAC31A2A}" dt="2022-12-27T21:22:35.680" v="3" actId="478"/>
          <ac:spMkLst>
            <pc:docMk/>
            <pc:sldMk cId="1598705153" sldId="257"/>
            <ac:spMk id="2" creationId="{17DC68AD-6F00-4D0F-A046-A4B8B89F4362}"/>
          </ac:spMkLst>
        </pc:spChg>
        <pc:spChg chg="del">
          <ac:chgData name="Dhakal, Kshitiz" userId="6ff78c19-3d13-44c6-91c3-34d44c8b7c49" providerId="ADAL" clId="{EF817F6B-6A0D-4BA2-9C68-FBAAAAC31A2A}" dt="2022-12-27T21:22:36.966" v="4" actId="478"/>
          <ac:spMkLst>
            <pc:docMk/>
            <pc:sldMk cId="1598705153" sldId="257"/>
            <ac:spMk id="3" creationId="{83A2AF22-87E5-4788-B2C1-E805FFE843AE}"/>
          </ac:spMkLst>
        </pc:spChg>
        <pc:picChg chg="add mod">
          <ac:chgData name="Dhakal, Kshitiz" userId="6ff78c19-3d13-44c6-91c3-34d44c8b7c49" providerId="ADAL" clId="{EF817F6B-6A0D-4BA2-9C68-FBAAAAC31A2A}" dt="2022-12-27T21:22:38.038" v="5"/>
          <ac:picMkLst>
            <pc:docMk/>
            <pc:sldMk cId="1598705153" sldId="257"/>
            <ac:picMk id="5" creationId="{7EDA0166-E006-4FFF-AFBE-6C0E62077A36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C0633B-7B75-4E37-8DE6-E0801DBC0C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1B8C764-A540-4BB4-B0B3-56EA6802BEA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CC8BE9-5F4E-4D2A-B892-BFADEDF21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5C2BB-27E0-4D42-80EA-6BA3E62BF2B7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6BCA1B-09BF-402B-94A7-220AC8D644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FCB54F-8683-4C8C-AE89-3ACDBD18D6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F07D1-3C02-4C31-AFB0-A76790067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67344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25C872-345A-4D2B-993B-C3BDA29F2E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778EFD6-7BD8-484D-B84E-847CB8725A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5BAC1E-07FF-46FE-BA30-FE02306B11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5C2BB-27E0-4D42-80EA-6BA3E62BF2B7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027E1E-4FC2-4F05-81D6-EF8F0106AA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FF80F6-1B37-4533-85CC-6BA0DE313D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F07D1-3C02-4C31-AFB0-A76790067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619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AD9FE64-8FCB-49A2-9081-FA941C13A1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A251565-21A8-42B3-AA98-0E48C8873F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947A93-EF2F-4AD6-8F60-66A6BBA1EC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5C2BB-27E0-4D42-80EA-6BA3E62BF2B7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CF53FD-FC55-4EB9-BC34-4CA1122380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DCDFA2-0628-4E0C-94AA-204AAB4589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F07D1-3C02-4C31-AFB0-A76790067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7847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1DFEE4-9FCB-4251-81F3-D69E373D83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0697E5-C04A-4952-94F3-324251F66B6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B9FF85-675F-4487-A5CC-EF14CD63DD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5C2BB-27E0-4D42-80EA-6BA3E62BF2B7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A39ED6-022D-45D3-B064-F5B9E37AB3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9CA67B-4813-46C1-8466-6077B2415D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F07D1-3C02-4C31-AFB0-A76790067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356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4799A3-D675-4128-A7F4-8BBCC6ADC9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4348AA-867D-47F5-827F-2EE276ACF9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5B3CE3-C189-48AF-B2B1-353E881D64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5C2BB-27E0-4D42-80EA-6BA3E62BF2B7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56CC48-220D-4646-A0E6-33234BE32C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5CDF6A-F292-4039-BC15-878867BF4C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F07D1-3C02-4C31-AFB0-A76790067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3166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2E02C4-0D12-4CF3-BC9D-FCF5FE1FBD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88A1CB-A5C3-4462-9537-9EBBF21CDF9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D3DEABA-5E8C-4895-946D-C047437A72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E043D4-B160-4047-89F1-F6766F9CD7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5C2BB-27E0-4D42-80EA-6BA3E62BF2B7}" type="datetimeFigureOut">
              <a:rPr lang="en-US" smtClean="0"/>
              <a:t>3/2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4FAE7F-9728-423D-BB55-BA3F14C285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799448-DF8E-4D6D-82A5-655C2626C2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F07D1-3C02-4C31-AFB0-A76790067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71827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115757-462F-4D68-BECE-B1CFC8DC39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4E5FB5-587F-42E3-997C-8D0C45BEC8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066A9B-41B2-4B7E-A9CA-1A6100EDDA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65A0F71-B4BF-4AC2-AD13-0B6E9BC4F09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632D71D-9288-4D77-BC97-B93EFB65DC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94DDFCF-4F59-4199-A189-5CCC204810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5C2BB-27E0-4D42-80EA-6BA3E62BF2B7}" type="datetimeFigureOut">
              <a:rPr lang="en-US" smtClean="0"/>
              <a:t>3/27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75DD9BB-20F1-459C-9B2B-271182E46A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323E2EA-9607-4A32-B398-DB31408B5C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F07D1-3C02-4C31-AFB0-A76790067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6402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AF9990-9BFC-47A3-9CE5-01F91E4C2C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46012BD-2656-4D30-8197-83A4FDD402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5C2BB-27E0-4D42-80EA-6BA3E62BF2B7}" type="datetimeFigureOut">
              <a:rPr lang="en-US" smtClean="0"/>
              <a:t>3/27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9205896-6CBE-462E-BB28-88A45BE75B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CE779A4-49BB-4931-99BA-0A0A7D8B7D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F07D1-3C02-4C31-AFB0-A76790067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0925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819366D-2CCC-4A73-AD34-EEF1B208BC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5C2BB-27E0-4D42-80EA-6BA3E62BF2B7}" type="datetimeFigureOut">
              <a:rPr lang="en-US" smtClean="0"/>
              <a:t>3/27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C5D9241-6D1B-4399-89B7-1BD428EC7D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5AD005D-E28E-4231-BD5B-61E6BE92E0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F07D1-3C02-4C31-AFB0-A76790067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131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5517B4-9A6E-4572-A3E8-6B92F716AE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793701-BA23-4963-957E-C6998408C1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FA19207-9D86-42BF-8AA6-F13D8399F0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51BC4E-1FBC-4292-AE3A-34320C2E74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5C2BB-27E0-4D42-80EA-6BA3E62BF2B7}" type="datetimeFigureOut">
              <a:rPr lang="en-US" smtClean="0"/>
              <a:t>3/2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56A905-8D0B-4295-83BC-0BA9131BE3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62208F-190A-4C99-BE1D-372DDEE3E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F07D1-3C02-4C31-AFB0-A76790067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17635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D8D394-B103-4D21-9A62-37DAEB12C4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FF5B904-AD34-4068-8FA9-4DE2D29C2DD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25AAF6-977E-4EEF-B3D7-06E6DFDE67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143614-6267-4B3E-9105-FA459F8835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5C2BB-27E0-4D42-80EA-6BA3E62BF2B7}" type="datetimeFigureOut">
              <a:rPr lang="en-US" smtClean="0"/>
              <a:t>3/2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94217EA-224D-4698-BED0-E593725BF4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D29975-08FB-4EF0-9497-BA2D7FE0B9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F07D1-3C02-4C31-AFB0-A76790067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1637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1B095B3-FCC7-4BA0-994C-026F60FDC7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F1B9C8-5E39-46F4-AB67-14E434BF32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5B0DAB-FC4D-4769-90F2-23071CFD09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15C2BB-27E0-4D42-80EA-6BA3E62BF2B7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B633E7-355B-4883-B428-F41BFC0BC9F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DDFF74-C00D-4F36-89F9-709F56F0B3D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FF07D1-3C02-4C31-AFB0-A76790067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870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EDA0166-E006-4FFF-AFBE-6C0E62077A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7000" y="0"/>
            <a:ext cx="6544638" cy="654463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91E14BB-67D5-43F5-EC83-B16CB2CF1F23}"/>
              </a:ext>
            </a:extLst>
          </p:cNvPr>
          <p:cNvSpPr txBox="1"/>
          <p:nvPr/>
        </p:nvSpPr>
        <p:spPr>
          <a:xfrm>
            <a:off x="421240" y="6488668"/>
            <a:ext cx="1152760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Figure S4: Confusion matrix of Mask R-CNN results obtained from cropped RGB images obtained from wheat kernels’ HSI.</a:t>
            </a:r>
          </a:p>
        </p:txBody>
      </p:sp>
    </p:spTree>
    <p:extLst>
      <p:ext uri="{BB962C8B-B14F-4D97-AF65-F5344CB8AC3E}">
        <p14:creationId xmlns:p14="http://schemas.microsoft.com/office/powerpoint/2010/main" val="15987051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38C0679CE3F1146B99428810CFFD1A5" ma:contentTypeVersion="13" ma:contentTypeDescription="Create a new document." ma:contentTypeScope="" ma:versionID="87104e6739588b1d33bffce79ec9ef76">
  <xsd:schema xmlns:xsd="http://www.w3.org/2001/XMLSchema" xmlns:xs="http://www.w3.org/2001/XMLSchema" xmlns:p="http://schemas.microsoft.com/office/2006/metadata/properties" xmlns:ns3="9435e4ad-f246-4104-a637-66c8bc3c99a7" xmlns:ns4="64ecab17-5948-449f-a717-624ba6338b70" targetNamespace="http://schemas.microsoft.com/office/2006/metadata/properties" ma:root="true" ma:fieldsID="0405a160c580c868c8adfe7b1b3dd395" ns3:_="" ns4:_="">
    <xsd:import namespace="9435e4ad-f246-4104-a637-66c8bc3c99a7"/>
    <xsd:import namespace="64ecab17-5948-449f-a717-624ba6338b70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LengthInSecond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435e4ad-f246-4104-a637-66c8bc3c99a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6" nillable="true" ma:displayName="MediaLengthInSeconds" ma:hidden="true" ma:internalName="MediaLengthInSeconds" ma:readOnly="true">
      <xsd:simpleType>
        <xsd:restriction base="dms:Unknown"/>
      </xsd:simpleType>
    </xsd:element>
    <xsd:element name="MediaServiceAutoTags" ma:index="17" nillable="true" ma:displayName="Tags" ma:internalName="MediaServiceAutoTags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4ecab17-5948-449f-a717-624ba6338b70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550A2F0B-76A9-41B0-A1ED-3023F2F12FC3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8A990740-D944-49E2-A789-3979EAC1F57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435e4ad-f246-4104-a637-66c8bc3c99a7"/>
    <ds:schemaRef ds:uri="64ecab17-5948-449f-a717-624ba6338b7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E5221BBE-B21A-4B18-92C7-AA4C01DCCA5E}">
  <ds:schemaRefs>
    <ds:schemaRef ds:uri="http://purl.org/dc/elements/1.1/"/>
    <ds:schemaRef ds:uri="http://purl.org/dc/terms/"/>
    <ds:schemaRef ds:uri="http://schemas.microsoft.com/office/2006/documentManagement/types"/>
    <ds:schemaRef ds:uri="http://purl.org/dc/dcmitype/"/>
    <ds:schemaRef ds:uri="http://www.w3.org/XML/1998/namespace"/>
    <ds:schemaRef ds:uri="9435e4ad-f246-4104-a637-66c8bc3c99a7"/>
    <ds:schemaRef ds:uri="64ecab17-5948-449f-a717-624ba6338b70"/>
    <ds:schemaRef ds:uri="http://schemas.microsoft.com/office/infopath/2007/PartnerControls"/>
    <ds:schemaRef ds:uri="http://schemas.openxmlformats.org/package/2006/metadata/core-properties"/>
    <ds:schemaRef ds:uri="http://schemas.microsoft.com/office/2006/metadata/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kal, Kshitiz</dc:creator>
  <cp:lastModifiedBy>song li</cp:lastModifiedBy>
  <cp:revision>2</cp:revision>
  <dcterms:created xsi:type="dcterms:W3CDTF">2022-12-27T21:22:27Z</dcterms:created>
  <dcterms:modified xsi:type="dcterms:W3CDTF">2023-03-28T00:18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38C0679CE3F1146B99428810CFFD1A5</vt:lpwstr>
  </property>
</Properties>
</file>